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 bookmarkIdSeed="24">
  <p:sldMasterIdLst>
    <p:sldMasterId id="2147483840" r:id="rId1"/>
  </p:sldMasterIdLst>
  <p:notesMasterIdLst>
    <p:notesMasterId r:id="rId3"/>
  </p:notesMasterIdLst>
  <p:sldIdLst>
    <p:sldId id="294" r:id="rId2"/>
  </p:sldIdLst>
  <p:sldSz cx="73152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11CD8B72-5FF1-4F32-8C2C-D7B4478E4F1D}">
          <p14:sldIdLst>
            <p14:sldId id="294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27FB36E-97C1-D6CC-FC60-8D30DA5DA027}" name="Arik Davidyan" initials="AD" userId="S::davidyana@omrf.org::8ca9df27-1e11-474e-a10a-be4812d5a88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830" autoAdjust="0"/>
    <p:restoredTop sz="93645" autoAdjust="0"/>
  </p:normalViewPr>
  <p:slideViewPr>
    <p:cSldViewPr snapToGrid="0">
      <p:cViewPr varScale="1">
        <p:scale>
          <a:sx n="111" d="100"/>
          <a:sy n="111" d="100"/>
        </p:scale>
        <p:origin x="4396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DA46E605-F6B1-403E-A899-FABDB04BC04A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3788" y="1162050"/>
            <a:ext cx="22828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4F2219B-4F43-4EA6-982C-2FB4872F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240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3326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3429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9885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719311A-ACB0-1F7B-D2CB-EC637A3F6E17}"/>
              </a:ext>
            </a:extLst>
          </p:cNvPr>
          <p:cNvCxnSpPr/>
          <p:nvPr userDrawn="1"/>
        </p:nvCxnSpPr>
        <p:spPr>
          <a:xfrm>
            <a:off x="870948" y="1477978"/>
            <a:ext cx="5764513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4926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804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6735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8630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6490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3709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8130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3108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87A34-81AB-432B-8DAE-1953F412C126}" type="datetimeFigureOut">
              <a:rPr lang="en-US" smtClean="0"/>
              <a:pPr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4732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134AE24-74AF-D3B4-468C-EB438CB4AB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3992632"/>
              </p:ext>
            </p:extLst>
          </p:nvPr>
        </p:nvGraphicFramePr>
        <p:xfrm>
          <a:off x="-43035" y="0"/>
          <a:ext cx="7295457" cy="39825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444919" imgH="5158035" progId="Prism10.Document">
                  <p:embed/>
                </p:oleObj>
              </mc:Choice>
              <mc:Fallback>
                <p:oleObj name="Prism 10" r:id="rId2" imgW="9444919" imgH="515803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43035" y="0"/>
                        <a:ext cx="7295457" cy="39825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B8F1BBD1-BD87-29FC-0FE9-3CBFEF41949F}"/>
              </a:ext>
            </a:extLst>
          </p:cNvPr>
          <p:cNvSpPr txBox="1"/>
          <p:nvPr/>
        </p:nvSpPr>
        <p:spPr>
          <a:xfrm>
            <a:off x="289420" y="3876950"/>
            <a:ext cx="673635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xtended Data Figure 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ADP titration curve with metformin administration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CR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LCR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The apparent Km of ADP was calculated using Michaelis-Menten Kinetics. Contribution of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Complex CII an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coupled respiration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 ratio of maximal coupled OXPHOS to uncoupled ETS (P/E) for th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lex I+II. </a:t>
            </a:r>
            <a:r>
              <a:rPr lang="en-US" sz="1200" dirty="0">
                <a:latin typeface="Arial" panose="020B0604020202020204" pitchFamily="34" charset="0"/>
                <a:ea typeface="Tahoma" pitchFamily="34" charset="0"/>
                <a:cs typeface="Arial" panose="020B0604020202020204" pitchFamily="34" charset="0"/>
              </a:rPr>
              <a:t>Data were analyzed by two-way ANOVA (group x treatment) and are represented as mean ± SEM from 6-7 rats per group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6DCC288-9195-4D55-8E87-9B538AAA53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2959495"/>
              </p:ext>
            </p:extLst>
          </p:nvPr>
        </p:nvGraphicFramePr>
        <p:xfrm>
          <a:off x="5987185" y="1396666"/>
          <a:ext cx="1074737" cy="5261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1907279" imgH="932882" progId="Prism9.Document">
                  <p:embed/>
                </p:oleObj>
              </mc:Choice>
              <mc:Fallback>
                <p:oleObj name="Prism 9" r:id="rId4" imgW="1907279" imgH="932882" progId="Prism9.Document">
                  <p:embed/>
                  <p:pic>
                    <p:nvPicPr>
                      <p:cNvPr id="55" name="Object 54">
                        <a:extLst>
                          <a:ext uri="{FF2B5EF4-FFF2-40B4-BE49-F238E27FC236}">
                            <a16:creationId xmlns:a16="http://schemas.microsoft.com/office/drawing/2014/main" id="{27BA69DA-6C9B-1428-60F8-9C2552FF6A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87185" y="1396666"/>
                        <a:ext cx="1074737" cy="5261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07132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403</TotalTime>
  <Words>92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10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formin treatment effects on protein turnover in the HCR/LCR rat model</dc:title>
  <dc:creator>Matt Bubak</dc:creator>
  <cp:lastModifiedBy>Matthew Bubak</cp:lastModifiedBy>
  <cp:revision>322</cp:revision>
  <cp:lastPrinted>2023-12-15T16:29:23Z</cp:lastPrinted>
  <dcterms:created xsi:type="dcterms:W3CDTF">2022-07-14T20:18:29Z</dcterms:created>
  <dcterms:modified xsi:type="dcterms:W3CDTF">2024-03-01T16:38:13Z</dcterms:modified>
</cp:coreProperties>
</file>